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2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28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6CDA57F-028B-440D-9EB1-D316B28608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2430A49-1A42-44D5-A50D-5EDB98CFB6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7EB40D3-7600-476A-99ED-8537A6A69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CEDFFD-FDC5-4289-946B-842A3EB73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081130-A7F3-48E7-9726-94969F469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295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F21079-B4FC-411D-BE13-ED6962F82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000616B-780E-439C-A8FE-F9278081EE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88C03C-5459-4898-83FF-DDB3857BD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5E4F7B5-0A67-4A9B-BCD1-88E102EE6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10629E7-BC92-47E4-90AF-26783D0B3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682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E6E9178-23AE-4978-9F6B-A72F58E77E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A3B083C-A68A-4E8F-80D6-F8159C815A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AF70FF0-04FE-48C0-8395-CFA0DE43B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17808F1-71AC-4BF7-B8EF-66D7A714E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8360370-0D13-42D1-8BF6-1F7D48480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0569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A7F2AB-6047-43B8-84A1-7615671B4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40A52A3-4B7D-42EC-AE89-1AE4BC23C2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CD0F1C8-6405-4CC7-AC97-A8365E4E9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7E85B68-54CE-4C12-8400-FAE98084A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37700C4-D63C-480F-90F2-D84BB4D61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7201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4D1CBF-010B-4B77-8004-EDA2F02556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42CF020-B6D5-43FD-B819-4BB80C276D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A2471BD-226A-44E5-ACA8-02CF28FBC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14AC31-9EC1-46C0-9A04-89761D32A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675243E-24AB-43C8-B1C2-4A3B15CBA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3414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1AA762-4934-443F-9F10-471115A63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E4367B9-B644-401A-802C-DFAB50EA03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F905FB2-DC6E-4B5B-8082-931AC63278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3737FFA-2341-4962-832B-7FF0413C5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EF0C40-F00C-45C8-B68B-A036D7B75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1D9A7DD-DBA1-4ADD-8E7C-E106EEB0E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7921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3AC4BD-F52A-4281-98FA-5A5B13EA4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BEBDE4C-74BF-4536-BCD3-10453EC108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60B486E-AA5C-4B1E-B7A6-E6EA770995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7F1ECC5-0819-4410-BB27-8BC3584956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F16B5E6-72D6-4F8D-B8C3-EF2FFE9E30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535D147-F776-475A-B834-AAA07208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C79BD11-C86F-469B-AA92-069B86316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5D2F85F-06A3-419C-B172-F6BF40F50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5618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52A2333-D059-47E4-98E5-AA88278A0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7DE0541-BD43-4108-AFDD-31A305BAB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BEC2667-31CB-4DC3-AF43-6AD3EAB50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B2AAEE1-96D1-45EC-8C49-8B3859A2F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1822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0547957-7B9E-4105-BE3F-4EF15CDAC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00FA5F0-3E63-4DD0-A027-55615D11D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E17554F-C436-4BED-9131-B1ADBB360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571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B3857A-6E6B-4068-9E37-7758E7938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60041E5-B458-4AE0-949D-4AF9F7E02D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0A63764-2F25-4A96-B564-CCF65C662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F74EA2F-7092-401F-B421-F5929EDCD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DE926C6-FC55-456D-ADE7-FEB35668A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8753750-C3FD-40C0-B94A-330739AE2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3229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0436A6-3E4E-4875-97BA-B60F43AC8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DEE18FD-C469-4FD6-A3CD-27841F8628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0384F2E-21F7-46CA-841A-E3534DD25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E28EE52-B376-4058-94CD-ED812594E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E9C138B-CAD6-46BB-8250-69B371223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FC4D4C3-6253-4D1F-B587-FD60079A3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4715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E696E36-0929-48D6-B96F-0F790E47E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A60F9CD-93BD-4E2A-81AE-634DDD943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F3788D8-C8A5-41BC-8994-E13BF23716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F7E47-130A-4646-8928-3FB5C9896C7F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3F383F4-172D-4F65-9F22-1F57BDDD86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6229B6D-CD4D-460F-B198-B017281313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29FA5-C9DE-48AF-A1FA-626C511747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2430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174D0E25-1617-43C3-A6F8-273F07D403A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069272" y="1126281"/>
            <a:ext cx="5402066" cy="4202464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9F949111-09B0-4472-8E60-353B6880DBC6}"/>
              </a:ext>
            </a:extLst>
          </p:cNvPr>
          <p:cNvSpPr txBox="1"/>
          <p:nvPr/>
        </p:nvSpPr>
        <p:spPr>
          <a:xfrm>
            <a:off x="1135116" y="5731719"/>
            <a:ext cx="10117083" cy="10306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ts val="14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ING network analysis of plasma proteins modulated by NAC during whole blood storage.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otein–protein interaction network generated with STRING using NAC-modulated proteins as input. The network was built with a first-shell setting including up to 10 additional interactors. Nodes represent proteins and edges represent known or predicted associations.</a:t>
            </a:r>
            <a:endParaRPr lang="it-IT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algn="just">
              <a:lnSpc>
                <a:spcPts val="14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it-IT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6380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5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igini Sonia</dc:creator>
  <cp:lastModifiedBy>Eligini Sonia</cp:lastModifiedBy>
  <cp:revision>6</cp:revision>
  <dcterms:created xsi:type="dcterms:W3CDTF">2026-03-25T08:58:17Z</dcterms:created>
  <dcterms:modified xsi:type="dcterms:W3CDTF">2026-06-12T14:21:04Z</dcterms:modified>
</cp:coreProperties>
</file>